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741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53150" y="762000"/>
            <a:ext cx="32766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. C458 concentration in 	organs of APP/PS1 mice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92C070A-10CD-9985-A4E5-7A8026C8DA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2774494"/>
              </p:ext>
            </p:extLst>
          </p:nvPr>
        </p:nvGraphicFramePr>
        <p:xfrm>
          <a:off x="1143000" y="1313020"/>
          <a:ext cx="3510280" cy="299456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55600">
                  <a:extLst>
                    <a:ext uri="{9D8B030D-6E8A-4147-A177-3AD203B41FA5}">
                      <a16:colId xmlns:a16="http://schemas.microsoft.com/office/drawing/2014/main" val="1650245755"/>
                    </a:ext>
                  </a:extLst>
                </a:gridCol>
                <a:gridCol w="749319">
                  <a:extLst>
                    <a:ext uri="{9D8B030D-6E8A-4147-A177-3AD203B41FA5}">
                      <a16:colId xmlns:a16="http://schemas.microsoft.com/office/drawing/2014/main" val="195906389"/>
                    </a:ext>
                  </a:extLst>
                </a:gridCol>
                <a:gridCol w="708711">
                  <a:extLst>
                    <a:ext uri="{9D8B030D-6E8A-4147-A177-3AD203B41FA5}">
                      <a16:colId xmlns:a16="http://schemas.microsoft.com/office/drawing/2014/main" val="3160645759"/>
                    </a:ext>
                  </a:extLst>
                </a:gridCol>
                <a:gridCol w="820350">
                  <a:extLst>
                    <a:ext uri="{9D8B030D-6E8A-4147-A177-3AD203B41FA5}">
                      <a16:colId xmlns:a16="http://schemas.microsoft.com/office/drawing/2014/main" val="3043393932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494243819"/>
                    </a:ext>
                  </a:extLst>
                </a:gridCol>
              </a:tblGrid>
              <a:tr h="836425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, ng/m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, n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rain, ng/g 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, </a:t>
                      </a:r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02385502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.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9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0060081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7.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9338978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.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1.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95778742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.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8.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6315216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.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4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9765359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.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.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5.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00404791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.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851714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09589660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.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5.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62090123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0.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38650817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.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5.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0802667"/>
                  </a:ext>
                </a:extLst>
              </a:tr>
              <a:tr h="1798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144" marR="7144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3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3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797511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6A7CE3C-A512-3F08-66BF-73B98FEB9410}"/>
              </a:ext>
            </a:extLst>
          </p:cNvPr>
          <p:cNvSpPr txBox="1"/>
          <p:nvPr/>
        </p:nvSpPr>
        <p:spPr>
          <a:xfrm>
            <a:off x="1190160" y="4441195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, male; F, female mice</a:t>
            </a:r>
          </a:p>
        </p:txBody>
      </p:sp>
    </p:spTree>
    <p:extLst>
      <p:ext uri="{BB962C8B-B14F-4D97-AF65-F5344CB8AC3E}">
        <p14:creationId xmlns:p14="http://schemas.microsoft.com/office/powerpoint/2010/main" val="1808215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2</TotalTime>
  <Words>100</Words>
  <Application>Microsoft Office PowerPoint</Application>
  <PresentationFormat>On-screen Show (4:3)</PresentationFormat>
  <Paragraphs>6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40:49Z</dcterms:modified>
</cp:coreProperties>
</file>